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268" r:id="rId2"/>
    <p:sldId id="269" r:id="rId3"/>
    <p:sldId id="271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04110D2D-9F43-F24B-B44D-9D28E6A6CCE4}">
          <p14:sldIdLst>
            <p14:sldId id="268"/>
          </p14:sldIdLst>
        </p14:section>
        <p14:section name="Supplementary Figures" id="{66E14E47-7582-AE49-BDB9-E67D19B9D52B}">
          <p14:sldIdLst>
            <p14:sldId id="269"/>
            <p14:sldId id="271"/>
          </p14:sldIdLst>
        </p14:section>
      </p14:sectionLst>
    </p:ex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432FF"/>
    <a:srgbClr val="2CF71A"/>
    <a:srgbClr val="0096FF"/>
    <a:srgbClr val="00FDFF"/>
    <a:srgbClr val="00FF00"/>
    <a:srgbClr val="95AEFF"/>
    <a:srgbClr val="50C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4660"/>
  </p:normalViewPr>
  <p:slideViewPr>
    <p:cSldViewPr snapToGrid="0" snapToObjects="1">
      <p:cViewPr varScale="1">
        <p:scale>
          <a:sx n="92" d="100"/>
          <a:sy n="92" d="100"/>
        </p:scale>
        <p:origin x="-3036" y="-12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F9EC868-A74C-2243-AD15-BB00385026E9}" type="datetimeFigureOut">
              <a:rPr lang="en-US" smtClean="0"/>
              <a:t>9/26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8C5D3F5-AADD-464C-822A-DFE3055581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7922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303889-F2ED-934A-A40A-F50FEF14F349}" type="datetimeFigureOut">
              <a:rPr lang="en-US" smtClean="0"/>
              <a:t>9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A28E85-9F7D-EE4C-83D7-DAEDC93450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98068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303889-F2ED-934A-A40A-F50FEF14F349}" type="datetimeFigureOut">
              <a:rPr lang="en-US" smtClean="0"/>
              <a:t>9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A28E85-9F7D-EE4C-83D7-DAEDC93450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08427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303889-F2ED-934A-A40A-F50FEF14F349}" type="datetimeFigureOut">
              <a:rPr lang="en-US" smtClean="0"/>
              <a:t>9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A28E85-9F7D-EE4C-83D7-DAEDC93450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49616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303889-F2ED-934A-A40A-F50FEF14F349}" type="datetimeFigureOut">
              <a:rPr lang="en-US" smtClean="0"/>
              <a:t>9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A28E85-9F7D-EE4C-83D7-DAEDC93450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57565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303889-F2ED-934A-A40A-F50FEF14F349}" type="datetimeFigureOut">
              <a:rPr lang="en-US" smtClean="0"/>
              <a:t>9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A28E85-9F7D-EE4C-83D7-DAEDC93450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01177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303889-F2ED-934A-A40A-F50FEF14F349}" type="datetimeFigureOut">
              <a:rPr lang="en-US" smtClean="0"/>
              <a:t>9/2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A28E85-9F7D-EE4C-83D7-DAEDC93450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64923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303889-F2ED-934A-A40A-F50FEF14F349}" type="datetimeFigureOut">
              <a:rPr lang="en-US" smtClean="0"/>
              <a:t>9/26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A28E85-9F7D-EE4C-83D7-DAEDC93450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15645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303889-F2ED-934A-A40A-F50FEF14F349}" type="datetimeFigureOut">
              <a:rPr lang="en-US" smtClean="0"/>
              <a:t>9/26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A28E85-9F7D-EE4C-83D7-DAEDC93450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42158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303889-F2ED-934A-A40A-F50FEF14F349}" type="datetimeFigureOut">
              <a:rPr lang="en-US" smtClean="0"/>
              <a:t>9/26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A28E85-9F7D-EE4C-83D7-DAEDC93450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55559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303889-F2ED-934A-A40A-F50FEF14F349}" type="datetimeFigureOut">
              <a:rPr lang="en-US" smtClean="0"/>
              <a:t>9/2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A28E85-9F7D-EE4C-83D7-DAEDC93450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09936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303889-F2ED-934A-A40A-F50FEF14F349}" type="datetimeFigureOut">
              <a:rPr lang="en-US" smtClean="0"/>
              <a:t>9/2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A28E85-9F7D-EE4C-83D7-DAEDC93450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57901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303889-F2ED-934A-A40A-F50FEF14F349}" type="datetimeFigureOut">
              <a:rPr lang="en-US" smtClean="0"/>
              <a:t>9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A28E85-9F7D-EE4C-83D7-DAEDC93450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09983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9108EB74-2CF3-D740-AA49-ABB40483FBE2}"/>
              </a:ext>
            </a:extLst>
          </p:cNvPr>
          <p:cNvSpPr txBox="1"/>
          <p:nvPr/>
        </p:nvSpPr>
        <p:spPr>
          <a:xfrm>
            <a:off x="324464" y="835741"/>
            <a:ext cx="5899355" cy="30469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Generation of isogenic controls for </a:t>
            </a:r>
            <a:r>
              <a:rPr lang="en-GB" b="1" i="1" dirty="0"/>
              <a:t>in vitro</a:t>
            </a:r>
            <a:r>
              <a:rPr lang="en-GB" b="1" dirty="0"/>
              <a:t> disease modelling of X-chromosomal disorders</a:t>
            </a:r>
            <a:endParaRPr lang="de-DE" b="1" dirty="0"/>
          </a:p>
          <a:p>
            <a:r>
              <a:rPr lang="de-DE" dirty="0"/>
              <a:t>Lisa Hinz</a:t>
            </a:r>
            <a:r>
              <a:rPr lang="de-DE" baseline="30000" dirty="0"/>
              <a:t>1,*</a:t>
            </a:r>
            <a:r>
              <a:rPr lang="de-DE" dirty="0"/>
              <a:t>, Stephanie D. Hoekstra</a:t>
            </a:r>
            <a:r>
              <a:rPr lang="de-DE" baseline="30000" dirty="0"/>
              <a:t>1,*</a:t>
            </a:r>
            <a:r>
              <a:rPr lang="de-DE" dirty="0"/>
              <a:t>, Kyoko Watanabe</a:t>
            </a:r>
            <a:r>
              <a:rPr lang="de-DE" baseline="30000" dirty="0"/>
              <a:t>1</a:t>
            </a:r>
            <a:r>
              <a:rPr lang="de-DE" dirty="0"/>
              <a:t>, Danielle Posthuma</a:t>
            </a:r>
            <a:r>
              <a:rPr lang="de-DE" baseline="30000" dirty="0"/>
              <a:t>1,2,#</a:t>
            </a:r>
            <a:r>
              <a:rPr lang="de-DE" dirty="0"/>
              <a:t>, </a:t>
            </a:r>
            <a:r>
              <a:rPr lang="de-DE" dirty="0" err="1"/>
              <a:t>Vivi</a:t>
            </a:r>
            <a:r>
              <a:rPr lang="de-DE" dirty="0"/>
              <a:t> M. Heine</a:t>
            </a:r>
            <a:r>
              <a:rPr lang="de-DE" baseline="30000" dirty="0"/>
              <a:t>1,3,#</a:t>
            </a:r>
          </a:p>
          <a:p>
            <a:endParaRPr lang="de-DE" dirty="0"/>
          </a:p>
          <a:p>
            <a:r>
              <a:rPr lang="en-US" sz="1200" i="1" baseline="30000" dirty="0"/>
              <a:t>1</a:t>
            </a:r>
            <a:r>
              <a:rPr lang="en-US" sz="1200" i="1" dirty="0"/>
              <a:t>Department of Complex Trait Genetics, Center for </a:t>
            </a:r>
            <a:r>
              <a:rPr lang="en-US" sz="1200" i="1" dirty="0" err="1"/>
              <a:t>Neurogenomics</a:t>
            </a:r>
            <a:r>
              <a:rPr lang="en-US" sz="1200" i="1" dirty="0"/>
              <a:t> and Cognitive Research, Amsterdam Neuroscience, </a:t>
            </a:r>
            <a:r>
              <a:rPr lang="en-US" sz="1200" i="1" dirty="0" err="1"/>
              <a:t>Vrije</a:t>
            </a:r>
            <a:r>
              <a:rPr lang="en-US" sz="1200" i="1" dirty="0"/>
              <a:t> </a:t>
            </a:r>
            <a:r>
              <a:rPr lang="en-US" sz="1200" i="1" dirty="0" err="1"/>
              <a:t>Universiteit</a:t>
            </a:r>
            <a:r>
              <a:rPr lang="en-US" sz="1200" i="1" dirty="0"/>
              <a:t>, Amsterdam, The Netherlands.  </a:t>
            </a:r>
            <a:r>
              <a:rPr lang="en-US" sz="1200" i="1" baseline="30000" dirty="0"/>
              <a:t>2</a:t>
            </a:r>
            <a:r>
              <a:rPr lang="en-US" sz="1200" i="1" dirty="0"/>
              <a:t>Department of Clinical Genetics, VU University Medical Center, Amsterdam Neuroscience, Amsterdam, The Netherlands. </a:t>
            </a:r>
            <a:r>
              <a:rPr lang="en-US" sz="1200" i="1" baseline="30000" dirty="0"/>
              <a:t>3</a:t>
            </a:r>
            <a:r>
              <a:rPr lang="en-US" sz="1200" i="1" dirty="0"/>
              <a:t>Department of Pediatrics / Child Neurology, VU University Medical Center, Amsterdam Neuroscience, Amsterdam, The Netherlands. </a:t>
            </a:r>
          </a:p>
          <a:p>
            <a:endParaRPr lang="en-US" sz="1200" i="1" dirty="0"/>
          </a:p>
          <a:p>
            <a:r>
              <a:rPr lang="en-US" sz="1200" i="1" dirty="0"/>
              <a:t>* Co-first authors. # Co-senior authors</a:t>
            </a:r>
            <a:endParaRPr lang="de-DE" sz="1200" dirty="0"/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6635056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xmlns="" id="{14995BA3-7ECE-C34B-B850-C9EDFFB2C2D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42709470"/>
              </p:ext>
            </p:extLst>
          </p:nvPr>
        </p:nvGraphicFramePr>
        <p:xfrm>
          <a:off x="1367574" y="1401364"/>
          <a:ext cx="3674582" cy="6693050"/>
        </p:xfrm>
        <a:graphic>
          <a:graphicData uri="http://schemas.openxmlformats.org/drawingml/2006/table">
            <a:tbl>
              <a:tblPr firstRow="1" firstCol="1" bandRow="1">
                <a:tableStyleId>{D7AC3CCA-C797-4891-BE02-D94E43425B78}</a:tableStyleId>
              </a:tblPr>
              <a:tblGrid>
                <a:gridCol w="918495">
                  <a:extLst>
                    <a:ext uri="{9D8B030D-6E8A-4147-A177-3AD203B41FA5}">
                      <a16:colId xmlns:a16="http://schemas.microsoft.com/office/drawing/2014/main" xmlns="" val="2632398893"/>
                    </a:ext>
                  </a:extLst>
                </a:gridCol>
                <a:gridCol w="2756087">
                  <a:extLst>
                    <a:ext uri="{9D8B030D-6E8A-4147-A177-3AD203B41FA5}">
                      <a16:colId xmlns:a16="http://schemas.microsoft.com/office/drawing/2014/main" xmlns="" val="3133880980"/>
                    </a:ext>
                  </a:extLst>
                </a:gridCol>
              </a:tblGrid>
              <a:tr h="536411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Bef>
                          <a:spcPts val="1000"/>
                        </a:spcBef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EIF4G2</a:t>
                      </a:r>
                      <a:endParaRPr lang="de-DE" sz="1100" dirty="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5005" marR="6500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>
                          <a:effectLst/>
                        </a:rPr>
                        <a:t>F: ATT CTT CGT TGT CAA GCC GCC AAA GTG GAG</a:t>
                      </a:r>
                      <a:endParaRPr lang="de-DE" sz="1100" b="0" dirty="0">
                        <a:effectLst/>
                      </a:endParaRPr>
                    </a:p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>
                          <a:effectLst/>
                        </a:rPr>
                        <a:t>R: AGT TGT TTG CTG CGG AGT TGT CAT CTC GTC</a:t>
                      </a:r>
                      <a:endParaRPr lang="de-DE" sz="1100" b="0" dirty="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5005" marR="65005" marT="0" marB="0"/>
                </a:tc>
                <a:extLst>
                  <a:ext uri="{0D108BD9-81ED-4DB2-BD59-A6C34878D82A}">
                    <a16:rowId xmlns:a16="http://schemas.microsoft.com/office/drawing/2014/main" xmlns="" val="3534384589"/>
                  </a:ext>
                </a:extLst>
              </a:tr>
              <a:tr h="536411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Bef>
                          <a:spcPts val="1000"/>
                        </a:spcBef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OCT3/4</a:t>
                      </a:r>
                      <a:endParaRPr lang="de-DE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5005" marR="6500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F: GAC AGG GGG AGG GGA GGA GCT AGG</a:t>
                      </a:r>
                      <a:endParaRPr lang="de-DE" sz="1100" dirty="0">
                        <a:effectLst/>
                      </a:endParaRPr>
                    </a:p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R: CTT CCC TCC AAC CAG TTG CCC CAA AC</a:t>
                      </a:r>
                      <a:endParaRPr lang="de-DE" sz="1100" dirty="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5005" marR="65005" marT="0" marB="0"/>
                </a:tc>
                <a:extLst>
                  <a:ext uri="{0D108BD9-81ED-4DB2-BD59-A6C34878D82A}">
                    <a16:rowId xmlns:a16="http://schemas.microsoft.com/office/drawing/2014/main" xmlns="" val="135646374"/>
                  </a:ext>
                </a:extLst>
              </a:tr>
              <a:tr h="536411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Bef>
                          <a:spcPts val="1000"/>
                        </a:spcBef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SOX2</a:t>
                      </a:r>
                      <a:endParaRPr lang="de-DE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5005" marR="6500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F: GGG AAA TGG GAG GGG TGC AAA AGA GG</a:t>
                      </a:r>
                      <a:endParaRPr lang="de-DE" sz="1100" dirty="0">
                        <a:effectLst/>
                      </a:endParaRPr>
                    </a:p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nl-NL" sz="900" dirty="0">
                          <a:effectLst/>
                        </a:rPr>
                        <a:t>R: TTG CGT GAG TGT GGA TGG GAT TGG TG</a:t>
                      </a:r>
                      <a:endParaRPr lang="de-DE" sz="1100" dirty="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5005" marR="65005" marT="0" marB="0"/>
                </a:tc>
                <a:extLst>
                  <a:ext uri="{0D108BD9-81ED-4DB2-BD59-A6C34878D82A}">
                    <a16:rowId xmlns:a16="http://schemas.microsoft.com/office/drawing/2014/main" xmlns="" val="1447495357"/>
                  </a:ext>
                </a:extLst>
              </a:tr>
              <a:tr h="536411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Bef>
                          <a:spcPts val="1000"/>
                        </a:spcBef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NANOG</a:t>
                      </a:r>
                      <a:endParaRPr lang="de-DE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5005" marR="6500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F: CAG CCC CGA TTC TTC CAC CAG TCC C</a:t>
                      </a:r>
                      <a:endParaRPr lang="de-DE" sz="1100" dirty="0">
                        <a:effectLst/>
                      </a:endParaRPr>
                    </a:p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R: CGG AAG ATT CCC AGT CGG GTT CAC C</a:t>
                      </a:r>
                      <a:endParaRPr lang="de-DE" sz="1100" dirty="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5005" marR="65005" marT="0" marB="0"/>
                </a:tc>
                <a:extLst>
                  <a:ext uri="{0D108BD9-81ED-4DB2-BD59-A6C34878D82A}">
                    <a16:rowId xmlns:a16="http://schemas.microsoft.com/office/drawing/2014/main" xmlns="" val="7356461"/>
                  </a:ext>
                </a:extLst>
              </a:tr>
              <a:tr h="536411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Bef>
                          <a:spcPts val="1000"/>
                        </a:spcBef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C-MYC</a:t>
                      </a:r>
                      <a:endParaRPr lang="de-DE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5005" marR="6500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F: GCG TCC TGG GAA GGG AGA TCC GGA GC</a:t>
                      </a:r>
                      <a:endParaRPr lang="de-DE" sz="1100" dirty="0">
                        <a:effectLst/>
                      </a:endParaRPr>
                    </a:p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R: TTG AGG GGC ATC GTC GCG GGA GGC TG</a:t>
                      </a:r>
                      <a:endParaRPr lang="de-DE" sz="1100" dirty="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5005" marR="65005" marT="0" marB="0"/>
                </a:tc>
                <a:extLst>
                  <a:ext uri="{0D108BD9-81ED-4DB2-BD59-A6C34878D82A}">
                    <a16:rowId xmlns:a16="http://schemas.microsoft.com/office/drawing/2014/main" xmlns="" val="1475403709"/>
                  </a:ext>
                </a:extLst>
              </a:tr>
              <a:tr h="536411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Bef>
                          <a:spcPts val="1000"/>
                        </a:spcBef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TDGF-1</a:t>
                      </a:r>
                      <a:endParaRPr lang="de-DE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5005" marR="6500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F: TGC TGC TCA CAG GGC CCG ATA CTT C</a:t>
                      </a:r>
                      <a:endParaRPr lang="de-DE" sz="1100" dirty="0">
                        <a:effectLst/>
                      </a:endParaRPr>
                    </a:p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R: TCC TTT CGA GCT CAG TGC ACC ACA AAA C</a:t>
                      </a:r>
                      <a:endParaRPr lang="de-DE" sz="1100" dirty="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5005" marR="65005" marT="0" marB="0"/>
                </a:tc>
                <a:extLst>
                  <a:ext uri="{0D108BD9-81ED-4DB2-BD59-A6C34878D82A}">
                    <a16:rowId xmlns:a16="http://schemas.microsoft.com/office/drawing/2014/main" xmlns="" val="4276716783"/>
                  </a:ext>
                </a:extLst>
              </a:tr>
              <a:tr h="536411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Bef>
                          <a:spcPts val="1000"/>
                        </a:spcBef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UTF-1</a:t>
                      </a:r>
                      <a:endParaRPr lang="de-DE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5005" marR="6500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F: CAG ATC CTA AAC AGC TCG CAG AAT</a:t>
                      </a:r>
                      <a:endParaRPr lang="de-DE" sz="1100">
                        <a:effectLst/>
                      </a:endParaRPr>
                    </a:p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R: GCG TAC GCA AAT TAA AGT CCA GA</a:t>
                      </a:r>
                      <a:endParaRPr lang="de-DE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5005" marR="65005" marT="0" marB="0"/>
                </a:tc>
                <a:extLst>
                  <a:ext uri="{0D108BD9-81ED-4DB2-BD59-A6C34878D82A}">
                    <a16:rowId xmlns:a16="http://schemas.microsoft.com/office/drawing/2014/main" xmlns="" val="2253271922"/>
                  </a:ext>
                </a:extLst>
              </a:tr>
              <a:tr h="536411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Bef>
                          <a:spcPts val="1000"/>
                        </a:spcBef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DNMT3B</a:t>
                      </a:r>
                      <a:endParaRPr lang="de-DE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5005" marR="6500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F: CAG GAG ACC TAC CCT CCA CA</a:t>
                      </a:r>
                      <a:endParaRPr lang="de-DE" sz="1100" dirty="0">
                        <a:effectLst/>
                      </a:endParaRPr>
                    </a:p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R: TGT CTG AAT TCC CGT TCT CC</a:t>
                      </a:r>
                      <a:endParaRPr lang="de-DE" sz="1100" dirty="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5005" marR="65005" marT="0" marB="0"/>
                </a:tc>
                <a:extLst>
                  <a:ext uri="{0D108BD9-81ED-4DB2-BD59-A6C34878D82A}">
                    <a16:rowId xmlns:a16="http://schemas.microsoft.com/office/drawing/2014/main" xmlns="" val="3164432681"/>
                  </a:ext>
                </a:extLst>
              </a:tr>
              <a:tr h="536411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Bef>
                          <a:spcPts val="1000"/>
                        </a:spcBef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XIST</a:t>
                      </a:r>
                      <a:endParaRPr lang="de-DE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5005" marR="6500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F: CTT TGA GAA TCT GGC CAA GC</a:t>
                      </a:r>
                      <a:endParaRPr lang="de-DE" sz="1100" dirty="0">
                        <a:effectLst/>
                      </a:endParaRPr>
                    </a:p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R: GGT TGT TGC CCA GTG GTA GT</a:t>
                      </a:r>
                      <a:endParaRPr lang="de-DE" sz="1100" dirty="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5005" marR="65005" marT="0" marB="0"/>
                </a:tc>
                <a:extLst>
                  <a:ext uri="{0D108BD9-81ED-4DB2-BD59-A6C34878D82A}">
                    <a16:rowId xmlns:a16="http://schemas.microsoft.com/office/drawing/2014/main" xmlns="" val="3815640086"/>
                  </a:ext>
                </a:extLst>
              </a:tr>
              <a:tr h="536411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Bef>
                          <a:spcPts val="1000"/>
                        </a:spcBef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MECP2</a:t>
                      </a:r>
                      <a:endParaRPr lang="de-DE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5005" marR="6500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nl-NL" sz="900" dirty="0">
                          <a:effectLst/>
                        </a:rPr>
                        <a:t>F: GGA GAA AAG TCC TGG AAG C</a:t>
                      </a:r>
                      <a:endParaRPr lang="de-DE" sz="1100" dirty="0">
                        <a:effectLst/>
                      </a:endParaRPr>
                    </a:p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R: CTT CAC GGC TTT CTT TTT GG</a:t>
                      </a:r>
                      <a:endParaRPr lang="de-DE" sz="1100" dirty="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5005" marR="65005" marT="0" marB="0"/>
                </a:tc>
                <a:extLst>
                  <a:ext uri="{0D108BD9-81ED-4DB2-BD59-A6C34878D82A}">
                    <a16:rowId xmlns:a16="http://schemas.microsoft.com/office/drawing/2014/main" xmlns="" val="1308016561"/>
                  </a:ext>
                </a:extLst>
              </a:tr>
              <a:tr h="636807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GAPDH</a:t>
                      </a:r>
                      <a:endParaRPr lang="de-DE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5005" marR="6500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F: TCA AGG GCA TCC TGG GCT AC</a:t>
                      </a:r>
                      <a:endParaRPr lang="de-DE" sz="1100" dirty="0">
                        <a:effectLst/>
                      </a:endParaRPr>
                    </a:p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R: CGT CAT GTC CGC TAG CTT CT</a:t>
                      </a:r>
                      <a:endParaRPr lang="de-DE" sz="1100" dirty="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5005" marR="65005" marT="0" marB="0"/>
                </a:tc>
                <a:extLst>
                  <a:ext uri="{0D108BD9-81ED-4DB2-BD59-A6C34878D82A}">
                    <a16:rowId xmlns:a16="http://schemas.microsoft.com/office/drawing/2014/main" xmlns="" val="2164091260"/>
                  </a:ext>
                </a:extLst>
              </a:tr>
              <a:tr h="569843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RPL13</a:t>
                      </a:r>
                      <a:endParaRPr lang="de-DE" sz="1100" dirty="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5005" marR="6500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nl-NL" sz="900" dirty="0">
                          <a:effectLst/>
                        </a:rPr>
                        <a:t>F: GAG ACA GTT CTG CTG AAG AAC TGA A</a:t>
                      </a:r>
                      <a:endParaRPr lang="de-DE" sz="1100" dirty="0">
                        <a:effectLst/>
                      </a:endParaRPr>
                    </a:p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nl-NL" sz="900" dirty="0">
                          <a:effectLst/>
                        </a:rPr>
                        <a:t>R: TCC GGA CGG GCA TGA C</a:t>
                      </a:r>
                      <a:endParaRPr lang="de-DE" sz="1100" dirty="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5005" marR="65005" marT="0" marB="0"/>
                </a:tc>
                <a:extLst>
                  <a:ext uri="{0D108BD9-81ED-4DB2-BD59-A6C34878D82A}">
                    <a16:rowId xmlns:a16="http://schemas.microsoft.com/office/drawing/2014/main" xmlns="" val="240134159"/>
                  </a:ext>
                </a:extLst>
              </a:tr>
            </a:tbl>
          </a:graphicData>
        </a:graphic>
      </p:graphicFrame>
      <p:sp>
        <p:nvSpPr>
          <p:cNvPr id="5" name="Rectangle 1">
            <a:extLst>
              <a:ext uri="{FF2B5EF4-FFF2-40B4-BE49-F238E27FC236}">
                <a16:creationId xmlns:a16="http://schemas.microsoft.com/office/drawing/2014/main" xmlns="" id="{637AE181-E5E4-F442-8254-540D93FDCB8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67574" y="1053311"/>
            <a:ext cx="4215065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de-DE" sz="1200" b="1" i="0" u="none" strike="noStrike" cap="none" normalizeH="0" baseline="0" dirty="0">
                <a:ln>
                  <a:noFill/>
                </a:ln>
                <a:effectLst/>
                <a:latin typeface="Cambria" panose="020405030504060302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Tab. S1 Primer-sets used for RT-PCR and quantitative PCR</a:t>
            </a:r>
            <a:endParaRPr kumimoji="0" lang="en-GB" altLang="de-DE" sz="1200" b="0" i="0" u="none" strike="noStrike" cap="none" normalizeH="0" baseline="0" dirty="0">
              <a:ln>
                <a:noFill/>
              </a:ln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altLang="de-DE" sz="12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837489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xmlns="" id="{F4650CA9-08D1-7445-BB1D-7553A9F9277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93787805"/>
              </p:ext>
            </p:extLst>
          </p:nvPr>
        </p:nvGraphicFramePr>
        <p:xfrm>
          <a:off x="956603" y="2158219"/>
          <a:ext cx="4543865" cy="2225040"/>
        </p:xfrm>
        <a:graphic>
          <a:graphicData uri="http://schemas.openxmlformats.org/drawingml/2006/table">
            <a:tbl>
              <a:tblPr firstRow="1" bandRow="1">
                <a:tableStyleId>{8EC20E35-A176-4012-BC5E-935CFFF8708E}</a:tableStyleId>
              </a:tblPr>
              <a:tblGrid>
                <a:gridCol w="1434905">
                  <a:extLst>
                    <a:ext uri="{9D8B030D-6E8A-4147-A177-3AD203B41FA5}">
                      <a16:colId xmlns:a16="http://schemas.microsoft.com/office/drawing/2014/main" xmlns="" val="2276950797"/>
                    </a:ext>
                  </a:extLst>
                </a:gridCol>
                <a:gridCol w="886265">
                  <a:extLst>
                    <a:ext uri="{9D8B030D-6E8A-4147-A177-3AD203B41FA5}">
                      <a16:colId xmlns:a16="http://schemas.microsoft.com/office/drawing/2014/main" xmlns="" val="373218258"/>
                    </a:ext>
                  </a:extLst>
                </a:gridCol>
                <a:gridCol w="1364566">
                  <a:extLst>
                    <a:ext uri="{9D8B030D-6E8A-4147-A177-3AD203B41FA5}">
                      <a16:colId xmlns:a16="http://schemas.microsoft.com/office/drawing/2014/main" xmlns="" val="3943692711"/>
                    </a:ext>
                  </a:extLst>
                </a:gridCol>
                <a:gridCol w="858129">
                  <a:extLst>
                    <a:ext uri="{9D8B030D-6E8A-4147-A177-3AD203B41FA5}">
                      <a16:colId xmlns:a16="http://schemas.microsoft.com/office/drawing/2014/main" xmlns="" val="4288246920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endParaRPr lang="en-GB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/>
                        <a:t>Time (sec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/>
                        <a:t>Temperature (°C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/>
                        <a:t>Repeat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24879498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GB" sz="1200" b="1" dirty="0"/>
                        <a:t>Initial denaturation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/>
                        <a:t>60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/>
                        <a:t>98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/>
                        <a:t>1x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24545675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GB" sz="1200" b="1" dirty="0"/>
                        <a:t>Denaturatio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/>
                        <a:t>5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/>
                        <a:t>98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3">
                  <a:txBody>
                    <a:bodyPr/>
                    <a:lstStyle/>
                    <a:p>
                      <a:pPr algn="ctr"/>
                      <a:endParaRPr lang="en-GB" sz="1200" dirty="0"/>
                    </a:p>
                    <a:p>
                      <a:pPr algn="ctr"/>
                      <a:endParaRPr lang="en-GB" sz="1200" dirty="0"/>
                    </a:p>
                    <a:p>
                      <a:pPr algn="ctr"/>
                      <a:r>
                        <a:rPr lang="en-GB" sz="1200" dirty="0"/>
                        <a:t>32x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69542215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GB" sz="1200" b="1" dirty="0"/>
                        <a:t>Annealing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/>
                        <a:t>1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/>
                        <a:t>60</a:t>
                      </a: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01517557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GB" sz="1200" b="1" dirty="0"/>
                        <a:t>Elongatio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/>
                        <a:t>15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/>
                        <a:t>72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56391847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GB" sz="1200" b="1" dirty="0"/>
                        <a:t>Final elongation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/>
                        <a:t>30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/>
                        <a:t>72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/>
                        <a:t>1x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xmlns="" val="3549780279"/>
                  </a:ext>
                </a:extLst>
              </a:tr>
            </a:tbl>
          </a:graphicData>
        </a:graphic>
      </p:graphicFrame>
      <p:sp>
        <p:nvSpPr>
          <p:cNvPr id="5" name="Rectangle 1">
            <a:extLst>
              <a:ext uri="{FF2B5EF4-FFF2-40B4-BE49-F238E27FC236}">
                <a16:creationId xmlns:a16="http://schemas.microsoft.com/office/drawing/2014/main" xmlns="" id="{21955C8B-675C-0840-B6D4-B4EC6EE23192}"/>
              </a:ext>
            </a:extLst>
          </p:cNvPr>
          <p:cNvSpPr>
            <a:spLocks noChangeArrowheads="1"/>
          </p:cNvSpPr>
          <p:nvPr/>
        </p:nvSpPr>
        <p:spPr bwMode="auto">
          <a:xfrm>
            <a:off x="956603" y="1828912"/>
            <a:ext cx="3177793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de-DE" sz="1200" b="1" i="0" u="none" strike="noStrike" cap="none" normalizeH="0" baseline="0" dirty="0">
                <a:ln>
                  <a:noFill/>
                </a:ln>
                <a:effectLst/>
                <a:latin typeface="Cambria" panose="020405030504060302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Tab. S2 PCR program used for PCR analysis</a:t>
            </a:r>
            <a:endParaRPr kumimoji="0" lang="en-GB" altLang="de-DE" sz="1200" b="0" i="0" u="none" strike="noStrike" cap="none" normalizeH="0" baseline="0" dirty="0">
              <a:ln>
                <a:noFill/>
              </a:ln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altLang="de-DE" sz="12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870857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32</TotalTime>
  <Words>405</Words>
  <Application>Microsoft Office PowerPoint</Application>
  <PresentationFormat>A4 Paper (210x297 mm)</PresentationFormat>
  <Paragraphs>67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Company>VU Amsterda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sa Hinz</dc:creator>
  <cp:lastModifiedBy>S3G_Apply_Fixed_Case</cp:lastModifiedBy>
  <cp:revision>198</cp:revision>
  <dcterms:created xsi:type="dcterms:W3CDTF">2017-03-30T12:13:45Z</dcterms:created>
  <dcterms:modified xsi:type="dcterms:W3CDTF">2018-09-25T19:22:57Z</dcterms:modified>
</cp:coreProperties>
</file>